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7" r:id="rId2"/>
  </p:sldIdLst>
  <p:sldSz cx="35999738" cy="359997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EA9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20" d="100"/>
          <a:sy n="20" d="100"/>
        </p:scale>
        <p:origin x="2550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699981" y="5891626"/>
            <a:ext cx="30599777" cy="12533242"/>
          </a:xfrm>
        </p:spPr>
        <p:txBody>
          <a:bodyPr anchor="b"/>
          <a:lstStyle>
            <a:lvl1pPr algn="ctr">
              <a:defRPr sz="23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499967" y="18908198"/>
            <a:ext cx="26999804" cy="8691601"/>
          </a:xfrm>
        </p:spPr>
        <p:txBody>
          <a:bodyPr/>
          <a:lstStyle>
            <a:lvl1pPr marL="0" indent="0" algn="ctr">
              <a:buNone/>
              <a:defRPr sz="9449"/>
            </a:lvl1pPr>
            <a:lvl2pPr marL="1799996" indent="0" algn="ctr">
              <a:buNone/>
              <a:defRPr sz="7874"/>
            </a:lvl2pPr>
            <a:lvl3pPr marL="3599993" indent="0" algn="ctr">
              <a:buNone/>
              <a:defRPr sz="7087"/>
            </a:lvl3pPr>
            <a:lvl4pPr marL="5399989" indent="0" algn="ctr">
              <a:buNone/>
              <a:defRPr sz="6299"/>
            </a:lvl4pPr>
            <a:lvl5pPr marL="7199986" indent="0" algn="ctr">
              <a:buNone/>
              <a:defRPr sz="6299"/>
            </a:lvl5pPr>
            <a:lvl6pPr marL="8999982" indent="0" algn="ctr">
              <a:buNone/>
              <a:defRPr sz="6299"/>
            </a:lvl6pPr>
            <a:lvl7pPr marL="10799978" indent="0" algn="ctr">
              <a:buNone/>
              <a:defRPr sz="6299"/>
            </a:lvl7pPr>
            <a:lvl8pPr marL="12599975" indent="0" algn="ctr">
              <a:buNone/>
              <a:defRPr sz="6299"/>
            </a:lvl8pPr>
            <a:lvl9pPr marL="14399971" indent="0" algn="ctr">
              <a:buNone/>
              <a:defRPr sz="6299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7636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1129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5762314" y="1916653"/>
            <a:ext cx="7762444" cy="3050811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474984" y="1916653"/>
            <a:ext cx="22837334" cy="30508114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9114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1693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56234" y="8974945"/>
            <a:ext cx="31049774" cy="14974888"/>
          </a:xfrm>
        </p:spPr>
        <p:txBody>
          <a:bodyPr anchor="b"/>
          <a:lstStyle>
            <a:lvl1pPr>
              <a:defRPr sz="23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56234" y="24091502"/>
            <a:ext cx="31049774" cy="7874940"/>
          </a:xfrm>
        </p:spPr>
        <p:txBody>
          <a:bodyPr/>
          <a:lstStyle>
            <a:lvl1pPr marL="0" indent="0">
              <a:buNone/>
              <a:defRPr sz="9449">
                <a:solidFill>
                  <a:schemeClr val="tx1"/>
                </a:solidFill>
              </a:defRPr>
            </a:lvl1pPr>
            <a:lvl2pPr marL="1799996" indent="0">
              <a:buNone/>
              <a:defRPr sz="7874">
                <a:solidFill>
                  <a:schemeClr val="tx1">
                    <a:tint val="75000"/>
                  </a:schemeClr>
                </a:solidFill>
              </a:defRPr>
            </a:lvl2pPr>
            <a:lvl3pPr marL="3599993" indent="0">
              <a:buNone/>
              <a:defRPr sz="7087">
                <a:solidFill>
                  <a:schemeClr val="tx1">
                    <a:tint val="75000"/>
                  </a:schemeClr>
                </a:solidFill>
              </a:defRPr>
            </a:lvl3pPr>
            <a:lvl4pPr marL="5399989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4pPr>
            <a:lvl5pPr marL="7199986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5pPr>
            <a:lvl6pPr marL="8999982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6pPr>
            <a:lvl7pPr marL="10799978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7pPr>
            <a:lvl8pPr marL="12599975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8pPr>
            <a:lvl9pPr marL="14399971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7174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74982" y="9583264"/>
            <a:ext cx="15299889" cy="2284150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24867" y="9583264"/>
            <a:ext cx="15299889" cy="2284150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928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1916661"/>
            <a:ext cx="31049774" cy="695828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9675" y="8824938"/>
            <a:ext cx="15229574" cy="4324966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96" indent="0">
              <a:buNone/>
              <a:defRPr sz="7874" b="1"/>
            </a:lvl2pPr>
            <a:lvl3pPr marL="3599993" indent="0">
              <a:buNone/>
              <a:defRPr sz="7087" b="1"/>
            </a:lvl3pPr>
            <a:lvl4pPr marL="5399989" indent="0">
              <a:buNone/>
              <a:defRPr sz="6299" b="1"/>
            </a:lvl4pPr>
            <a:lvl5pPr marL="7199986" indent="0">
              <a:buNone/>
              <a:defRPr sz="6299" b="1"/>
            </a:lvl5pPr>
            <a:lvl6pPr marL="8999982" indent="0">
              <a:buNone/>
              <a:defRPr sz="6299" b="1"/>
            </a:lvl6pPr>
            <a:lvl7pPr marL="10799978" indent="0">
              <a:buNone/>
              <a:defRPr sz="6299" b="1"/>
            </a:lvl7pPr>
            <a:lvl8pPr marL="12599975" indent="0">
              <a:buNone/>
              <a:defRPr sz="6299" b="1"/>
            </a:lvl8pPr>
            <a:lvl9pPr marL="14399971" indent="0">
              <a:buNone/>
              <a:defRPr sz="629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79675" y="13149904"/>
            <a:ext cx="15229574" cy="1934152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224869" y="8824938"/>
            <a:ext cx="15304578" cy="4324966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96" indent="0">
              <a:buNone/>
              <a:defRPr sz="7874" b="1"/>
            </a:lvl2pPr>
            <a:lvl3pPr marL="3599993" indent="0">
              <a:buNone/>
              <a:defRPr sz="7087" b="1"/>
            </a:lvl3pPr>
            <a:lvl4pPr marL="5399989" indent="0">
              <a:buNone/>
              <a:defRPr sz="6299" b="1"/>
            </a:lvl4pPr>
            <a:lvl5pPr marL="7199986" indent="0">
              <a:buNone/>
              <a:defRPr sz="6299" b="1"/>
            </a:lvl5pPr>
            <a:lvl6pPr marL="8999982" indent="0">
              <a:buNone/>
              <a:defRPr sz="6299" b="1"/>
            </a:lvl6pPr>
            <a:lvl7pPr marL="10799978" indent="0">
              <a:buNone/>
              <a:defRPr sz="6299" b="1"/>
            </a:lvl7pPr>
            <a:lvl8pPr marL="12599975" indent="0">
              <a:buNone/>
              <a:defRPr sz="6299" b="1"/>
            </a:lvl8pPr>
            <a:lvl9pPr marL="14399971" indent="0">
              <a:buNone/>
              <a:defRPr sz="629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224869" y="13149904"/>
            <a:ext cx="15304578" cy="1934152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0898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3822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6519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2399982"/>
            <a:ext cx="11610853" cy="8399939"/>
          </a:xfrm>
        </p:spPr>
        <p:txBody>
          <a:bodyPr anchor="b"/>
          <a:lstStyle>
            <a:lvl1pPr>
              <a:defRPr sz="1259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304578" y="5183304"/>
            <a:ext cx="18224867" cy="25583147"/>
          </a:xfrm>
        </p:spPr>
        <p:txBody>
          <a:bodyPr/>
          <a:lstStyle>
            <a:lvl1pPr>
              <a:defRPr sz="12598"/>
            </a:lvl1pPr>
            <a:lvl2pPr>
              <a:defRPr sz="11024"/>
            </a:lvl2pPr>
            <a:lvl3pPr>
              <a:defRPr sz="9449"/>
            </a:lvl3pPr>
            <a:lvl4pPr>
              <a:defRPr sz="7874"/>
            </a:lvl4pPr>
            <a:lvl5pPr>
              <a:defRPr sz="7874"/>
            </a:lvl5pPr>
            <a:lvl6pPr>
              <a:defRPr sz="7874"/>
            </a:lvl6pPr>
            <a:lvl7pPr>
              <a:defRPr sz="7874"/>
            </a:lvl7pPr>
            <a:lvl8pPr>
              <a:defRPr sz="7874"/>
            </a:lvl8pPr>
            <a:lvl9pPr>
              <a:defRPr sz="7874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79671" y="10799922"/>
            <a:ext cx="11610853" cy="20008190"/>
          </a:xfrm>
        </p:spPr>
        <p:txBody>
          <a:bodyPr/>
          <a:lstStyle>
            <a:lvl1pPr marL="0" indent="0">
              <a:buNone/>
              <a:defRPr sz="6299"/>
            </a:lvl1pPr>
            <a:lvl2pPr marL="1799996" indent="0">
              <a:buNone/>
              <a:defRPr sz="5512"/>
            </a:lvl2pPr>
            <a:lvl3pPr marL="3599993" indent="0">
              <a:buNone/>
              <a:defRPr sz="4724"/>
            </a:lvl3pPr>
            <a:lvl4pPr marL="5399989" indent="0">
              <a:buNone/>
              <a:defRPr sz="3937"/>
            </a:lvl4pPr>
            <a:lvl5pPr marL="7199986" indent="0">
              <a:buNone/>
              <a:defRPr sz="3937"/>
            </a:lvl5pPr>
            <a:lvl6pPr marL="8999982" indent="0">
              <a:buNone/>
              <a:defRPr sz="3937"/>
            </a:lvl6pPr>
            <a:lvl7pPr marL="10799978" indent="0">
              <a:buNone/>
              <a:defRPr sz="3937"/>
            </a:lvl7pPr>
            <a:lvl8pPr marL="12599975" indent="0">
              <a:buNone/>
              <a:defRPr sz="3937"/>
            </a:lvl8pPr>
            <a:lvl9pPr marL="14399971" indent="0">
              <a:buNone/>
              <a:defRPr sz="3937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36931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2399982"/>
            <a:ext cx="11610853" cy="8399939"/>
          </a:xfrm>
        </p:spPr>
        <p:txBody>
          <a:bodyPr anchor="b"/>
          <a:lstStyle>
            <a:lvl1pPr>
              <a:defRPr sz="1259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304578" y="5183304"/>
            <a:ext cx="18224867" cy="25583147"/>
          </a:xfrm>
        </p:spPr>
        <p:txBody>
          <a:bodyPr anchor="t"/>
          <a:lstStyle>
            <a:lvl1pPr marL="0" indent="0">
              <a:buNone/>
              <a:defRPr sz="12598"/>
            </a:lvl1pPr>
            <a:lvl2pPr marL="1799996" indent="0">
              <a:buNone/>
              <a:defRPr sz="11024"/>
            </a:lvl2pPr>
            <a:lvl3pPr marL="3599993" indent="0">
              <a:buNone/>
              <a:defRPr sz="9449"/>
            </a:lvl3pPr>
            <a:lvl4pPr marL="5399989" indent="0">
              <a:buNone/>
              <a:defRPr sz="7874"/>
            </a:lvl4pPr>
            <a:lvl5pPr marL="7199986" indent="0">
              <a:buNone/>
              <a:defRPr sz="7874"/>
            </a:lvl5pPr>
            <a:lvl6pPr marL="8999982" indent="0">
              <a:buNone/>
              <a:defRPr sz="7874"/>
            </a:lvl6pPr>
            <a:lvl7pPr marL="10799978" indent="0">
              <a:buNone/>
              <a:defRPr sz="7874"/>
            </a:lvl7pPr>
            <a:lvl8pPr marL="12599975" indent="0">
              <a:buNone/>
              <a:defRPr sz="7874"/>
            </a:lvl8pPr>
            <a:lvl9pPr marL="14399971" indent="0">
              <a:buNone/>
              <a:defRPr sz="7874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79671" y="10799922"/>
            <a:ext cx="11610853" cy="20008190"/>
          </a:xfrm>
        </p:spPr>
        <p:txBody>
          <a:bodyPr/>
          <a:lstStyle>
            <a:lvl1pPr marL="0" indent="0">
              <a:buNone/>
              <a:defRPr sz="6299"/>
            </a:lvl1pPr>
            <a:lvl2pPr marL="1799996" indent="0">
              <a:buNone/>
              <a:defRPr sz="5512"/>
            </a:lvl2pPr>
            <a:lvl3pPr marL="3599993" indent="0">
              <a:buNone/>
              <a:defRPr sz="4724"/>
            </a:lvl3pPr>
            <a:lvl4pPr marL="5399989" indent="0">
              <a:buNone/>
              <a:defRPr sz="3937"/>
            </a:lvl4pPr>
            <a:lvl5pPr marL="7199986" indent="0">
              <a:buNone/>
              <a:defRPr sz="3937"/>
            </a:lvl5pPr>
            <a:lvl6pPr marL="8999982" indent="0">
              <a:buNone/>
              <a:defRPr sz="3937"/>
            </a:lvl6pPr>
            <a:lvl7pPr marL="10799978" indent="0">
              <a:buNone/>
              <a:defRPr sz="3937"/>
            </a:lvl7pPr>
            <a:lvl8pPr marL="12599975" indent="0">
              <a:buNone/>
              <a:defRPr sz="3937"/>
            </a:lvl8pPr>
            <a:lvl9pPr marL="14399971" indent="0">
              <a:buNone/>
              <a:defRPr sz="3937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64807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474982" y="1916661"/>
            <a:ext cx="31049774" cy="695828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4982" y="9583264"/>
            <a:ext cx="31049774" cy="228415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474982" y="33366432"/>
            <a:ext cx="8099941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924913" y="33366432"/>
            <a:ext cx="12149912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424815" y="33366432"/>
            <a:ext cx="8099941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135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599993" rtl="0" eaLnBrk="1" latinLnBrk="0" hangingPunct="1">
        <a:lnSpc>
          <a:spcPct val="90000"/>
        </a:lnSpc>
        <a:spcBef>
          <a:spcPct val="0"/>
        </a:spcBef>
        <a:buNone/>
        <a:defRPr sz="1732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99998" indent="-899998" algn="l" defTabSz="3599993" rtl="0" eaLnBrk="1" latinLnBrk="0" hangingPunct="1">
        <a:lnSpc>
          <a:spcPct val="90000"/>
        </a:lnSpc>
        <a:spcBef>
          <a:spcPts val="3937"/>
        </a:spcBef>
        <a:buFont typeface="Arial" panose="020B0604020202020204" pitchFamily="34" charset="0"/>
        <a:buChar char="•"/>
        <a:defRPr sz="11024" kern="1200">
          <a:solidFill>
            <a:schemeClr val="tx1"/>
          </a:solidFill>
          <a:latin typeface="+mn-lt"/>
          <a:ea typeface="+mn-ea"/>
          <a:cs typeface="+mn-cs"/>
        </a:defRPr>
      </a:lvl1pPr>
      <a:lvl2pPr marL="2699995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9449" kern="1200">
          <a:solidFill>
            <a:schemeClr val="tx1"/>
          </a:solidFill>
          <a:latin typeface="+mn-lt"/>
          <a:ea typeface="+mn-ea"/>
          <a:cs typeface="+mn-cs"/>
        </a:defRPr>
      </a:lvl2pPr>
      <a:lvl3pPr marL="4499991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874" kern="1200">
          <a:solidFill>
            <a:schemeClr val="tx1"/>
          </a:solidFill>
          <a:latin typeface="+mn-lt"/>
          <a:ea typeface="+mn-ea"/>
          <a:cs typeface="+mn-cs"/>
        </a:defRPr>
      </a:lvl3pPr>
      <a:lvl4pPr marL="6299987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4pPr>
      <a:lvl5pPr marL="8099984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5pPr>
      <a:lvl6pPr marL="9899980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6pPr>
      <a:lvl7pPr marL="11699977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7pPr>
      <a:lvl8pPr marL="13499973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8pPr>
      <a:lvl9pPr marL="15299969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1pPr>
      <a:lvl2pPr marL="1799996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2pPr>
      <a:lvl3pPr marL="3599993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3pPr>
      <a:lvl4pPr marL="5399989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4pPr>
      <a:lvl5pPr marL="7199986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5pPr>
      <a:lvl6pPr marL="8999982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6pPr>
      <a:lvl7pPr marL="10799978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7pPr>
      <a:lvl8pPr marL="12599975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8pPr>
      <a:lvl9pPr marL="14399971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4AE950B4-89D3-4E2A-A3F1-6DF20248C2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5154672"/>
              </p:ext>
            </p:extLst>
          </p:nvPr>
        </p:nvGraphicFramePr>
        <p:xfrm>
          <a:off x="38100" y="502172"/>
          <a:ext cx="35797671" cy="29578851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019300">
                  <a:extLst>
                    <a:ext uri="{9D8B030D-6E8A-4147-A177-3AD203B41FA5}">
                      <a16:colId xmlns:a16="http://schemas.microsoft.com/office/drawing/2014/main" val="3780745624"/>
                    </a:ext>
                  </a:extLst>
                </a:gridCol>
                <a:gridCol w="3429000">
                  <a:extLst>
                    <a:ext uri="{9D8B030D-6E8A-4147-A177-3AD203B41FA5}">
                      <a16:colId xmlns:a16="http://schemas.microsoft.com/office/drawing/2014/main" val="499345670"/>
                    </a:ext>
                  </a:extLst>
                </a:gridCol>
                <a:gridCol w="3038168">
                  <a:extLst>
                    <a:ext uri="{9D8B030D-6E8A-4147-A177-3AD203B41FA5}">
                      <a16:colId xmlns:a16="http://schemas.microsoft.com/office/drawing/2014/main" val="297704912"/>
                    </a:ext>
                  </a:extLst>
                </a:gridCol>
                <a:gridCol w="2654709">
                  <a:extLst>
                    <a:ext uri="{9D8B030D-6E8A-4147-A177-3AD203B41FA5}">
                      <a16:colId xmlns:a16="http://schemas.microsoft.com/office/drawing/2014/main" val="2613630306"/>
                    </a:ext>
                  </a:extLst>
                </a:gridCol>
                <a:gridCol w="3716594">
                  <a:extLst>
                    <a:ext uri="{9D8B030D-6E8A-4147-A177-3AD203B41FA5}">
                      <a16:colId xmlns:a16="http://schemas.microsoft.com/office/drawing/2014/main" val="1333612574"/>
                    </a:ext>
                  </a:extLst>
                </a:gridCol>
                <a:gridCol w="1917290">
                  <a:extLst>
                    <a:ext uri="{9D8B030D-6E8A-4147-A177-3AD203B41FA5}">
                      <a16:colId xmlns:a16="http://schemas.microsoft.com/office/drawing/2014/main" val="242835973"/>
                    </a:ext>
                  </a:extLst>
                </a:gridCol>
                <a:gridCol w="4837471">
                  <a:extLst>
                    <a:ext uri="{9D8B030D-6E8A-4147-A177-3AD203B41FA5}">
                      <a16:colId xmlns:a16="http://schemas.microsoft.com/office/drawing/2014/main" val="2895600101"/>
                    </a:ext>
                  </a:extLst>
                </a:gridCol>
                <a:gridCol w="3392129">
                  <a:extLst>
                    <a:ext uri="{9D8B030D-6E8A-4147-A177-3AD203B41FA5}">
                      <a16:colId xmlns:a16="http://schemas.microsoft.com/office/drawing/2014/main" val="87034710"/>
                    </a:ext>
                  </a:extLst>
                </a:gridCol>
                <a:gridCol w="2772697">
                  <a:extLst>
                    <a:ext uri="{9D8B030D-6E8A-4147-A177-3AD203B41FA5}">
                      <a16:colId xmlns:a16="http://schemas.microsoft.com/office/drawing/2014/main" val="4006168732"/>
                    </a:ext>
                  </a:extLst>
                </a:gridCol>
                <a:gridCol w="5840361">
                  <a:extLst>
                    <a:ext uri="{9D8B030D-6E8A-4147-A177-3AD203B41FA5}">
                      <a16:colId xmlns:a16="http://schemas.microsoft.com/office/drawing/2014/main" val="872980562"/>
                    </a:ext>
                  </a:extLst>
                </a:gridCol>
                <a:gridCol w="2179952">
                  <a:extLst>
                    <a:ext uri="{9D8B030D-6E8A-4147-A177-3AD203B41FA5}">
                      <a16:colId xmlns:a16="http://schemas.microsoft.com/office/drawing/2014/main" val="4042322082"/>
                    </a:ext>
                  </a:extLst>
                </a:gridCol>
              </a:tblGrid>
              <a:tr h="992288">
                <a:tc>
                  <a:txBody>
                    <a:bodyPr/>
                    <a:lstStyle/>
                    <a:p>
                      <a:r>
                        <a:rPr lang="en-US" altLang="zh-CN" sz="36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utcome</a:t>
                      </a:r>
                      <a:endParaRPr lang="zh-CN" altLang="en-US" sz="36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6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xposure</a:t>
                      </a:r>
                      <a:endParaRPr lang="zh-CN" altLang="en-US" sz="36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od</a:t>
                      </a:r>
                      <a:endParaRPr lang="zh-CN" altLang="en-US" sz="36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o of SNPs</a:t>
                      </a:r>
                      <a:endParaRPr lang="zh-CN" altLang="en-US" sz="36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R(95%CI)</a:t>
                      </a:r>
                      <a:endParaRPr lang="zh-CN" altLang="en-US" sz="36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 value</a:t>
                      </a:r>
                      <a:endParaRPr lang="zh-CN" altLang="en-US" sz="36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xposure</a:t>
                      </a:r>
                      <a:endParaRPr lang="zh-CN" altLang="en-US" sz="36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hod</a:t>
                      </a:r>
                      <a:endParaRPr lang="zh-CN" altLang="en-US" sz="36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o of SNPs</a:t>
                      </a:r>
                      <a:endParaRPr lang="zh-CN" altLang="en-US" sz="36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R(95%CI)</a:t>
                      </a:r>
                      <a:endParaRPr lang="zh-CN" altLang="en-US" sz="36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6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 value</a:t>
                      </a:r>
                      <a:endParaRPr lang="zh-CN" altLang="en-US" sz="36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9188143"/>
                  </a:ext>
                </a:extLst>
              </a:tr>
              <a:tr h="605923">
                <a:tc rowSpan="52">
                  <a:txBody>
                    <a:bodyPr/>
                    <a:lstStyle/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ctr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ervical spondylosis</a:t>
                      </a:r>
                    </a:p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HB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76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70 (0.795 to 0.951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2e-03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ype 2 diabet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9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40 (0.985 to 1.099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065118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76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38 (0.801 to 1.099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3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9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44 (0.931 to 1.171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6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3350112"/>
                  </a:ext>
                </a:extLst>
              </a:tr>
              <a:tr h="261794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76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58 (0.741 to 0.994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1e-0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9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44 (0.958 to 1.137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3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831676"/>
                  </a:ext>
                </a:extLst>
              </a:tr>
              <a:tr h="261794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82 (0.809 to 0.954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9e-03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44 (0.987 to 1.101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3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242148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moking initiat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4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56 (1.061 to 1.486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1e-03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ajor depress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7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70 (1.017 to 1.587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5e-0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076783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4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60 (0.284 to 1.533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6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7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34 (0.068 to 0.806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5e-0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355490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4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31 (0.966 to 1.569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.3e-0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7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10 (0.904 to 1.619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9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2707996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328 (1.114 to 1.542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7e-04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52 (0.981 to 1.523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7e-0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915010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moking heavines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75 (0.940 to 1.228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9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F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36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322 (1.097 to 1.593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3e-03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416304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29 (0.734 to 1.174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5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36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26 (0.828 to 3.190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32058518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75 (0.812 to 1.170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8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36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33 (0.851 to 1.508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9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422388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78 (0.937 to 1.218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7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337 (1.093 to 1.581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0e-03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7470318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lcoholic drinkin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09 (0.539 to 1.680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9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itting height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4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50 (1.025 to 1.291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7e-0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203760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186 (-0.365 to 4.738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4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54 (0.964 to 1.631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7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156091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14 (0.536 to 2.693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9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4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19 (0.951 to 1.317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.1e-0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884112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50 (0.564 to 1.735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9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*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31 (1.008 to 1.255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7e-0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626130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offee intak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42 (0.750 to 1.738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3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eisure activit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93 (1.26e-02 to 6.79e+00 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4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203181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93 (0.422 to 2.338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7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45 (1.39e-12 to 2.66e+18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8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172738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51 (0.512 to 1.767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.9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028 (1.24e-01 to 2.94e+02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7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280005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48 (0.684 to 1.611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1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93 (-0.628 to 1.215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7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644945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atching TV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8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960 (1.391 to 2.760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8e-04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hysical activit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9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16 (0.409 to 4.626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6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895405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8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122 (1.247 to 30.046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7e-0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9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05 (0.006 to 1.786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5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2981279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8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366 (1.452 to 3.855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4e-04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9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17 (0.304 to 1.693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4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7645132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095 (1.381 to 2.095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4e-05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16 (0.253 to 1.378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7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55390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sing comput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8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45 (0.418 to 0.995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7e-0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JIM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022 (1.054 to 3.879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4e-0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510387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8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99 (0.017 to 2.346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0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87 (0.023 to 26.902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9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806446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8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90 (0.393 to 1.210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9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556 (0.716 to 3.378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6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227266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32 (0.362 to 0.900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7e-0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469 (1.049 to 3.888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1e-03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496728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MI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63 (1.125 to 1.418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5e-05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JIW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5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62 (0.951 to 2.908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4e-0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960023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81 (0.793 to 1.474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2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5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82 (0.097 to 6.318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2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127396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47 (0.955 to 1.378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4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5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405 (0.723 to 2.727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1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824000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47 (1.108 to 1.386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e-04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598 (0.747 to 2.450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0172278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ype 1 diabet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82 (0.954 to 1.011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3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steoporosi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285e-02 (3.491e-04 to 1.132e+01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9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478170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26 (0.981 to 1.075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8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388e-02 (3.739e-13 to 1.525e+09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3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8961622"/>
                  </a:ext>
                </a:extLst>
              </a:tr>
              <a:tr h="501232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95 (0.961 to 1.030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9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068e-03 (2.939e-06 to 5.630e+00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7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4821531"/>
                  </a:ext>
                </a:extLst>
              </a:tr>
              <a:tr h="277057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94 (0.970 to 1.017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0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63 (-0.219 to 0.345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4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2054010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riglycerid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4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69 (0.846 to 1.111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5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otal Testostero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37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37 (0842 to 1.044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4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108636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4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49 (0.681 to 1.060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5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37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20 (0.842 to 1.235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4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014990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4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62 (0.808 to 1.144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6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37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97 (0.838 to 1.185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.7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622568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*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53 (0.820 to 1.086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0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52 (0.853 to 1.052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6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146307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DL –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5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04 (0.826 to 0.990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9e-0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erum 25-Hydroxyvitamin 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75 (0.890 to 1.299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5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785985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75 (0.841 to 1.130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4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46 (0.694 to 1.288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2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063280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45 (0.813 to 1.098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6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85 (0.664 to 1.179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5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90854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99 (0.819 to 0.981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4e-0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*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82 (0.874 to 1.291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2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759976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DL –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48 (0.870 to 1.033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2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M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30 (0.999 to 1.277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1e-0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096676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66 (0.860 to 1.084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5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49 (0.708 to 1.865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8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731307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07 (0.809 to 1.018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.7e-0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85 (0.987 to 1.270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1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996880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56 (0.877 to 1.035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9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17 (0.986 to 1.249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9e-0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679677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ousehold incom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3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18 (0.567 to 1.179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8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holesterol, tota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VW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8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27 (0.838 to 1.025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3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166143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3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36 (0.037 to 1.491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3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Egger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8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47 (0.806 to 1.112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1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489691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3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95 (0.611 to 1.620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.8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eighted median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8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75 (0.755 to 1.015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8e-02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722224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5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67 (0.496 to 1.038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4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3599993" rtl="0" eaLnBrk="1" latinLnBrk="0" hangingPunct="1"/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R PRESSO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22 (0.831 to 1.013)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0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e-01</a:t>
                      </a:r>
                      <a:endParaRPr lang="zh-CN" altLang="en-US" sz="30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804093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034417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01</TotalTime>
  <Words>1108</Words>
  <Application>Microsoft Office PowerPoint</Application>
  <PresentationFormat>自定义</PresentationFormat>
  <Paragraphs>48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任震晓</dc:creator>
  <cp:lastModifiedBy>任震晓</cp:lastModifiedBy>
  <cp:revision>347</cp:revision>
  <dcterms:created xsi:type="dcterms:W3CDTF">2023-07-13T08:08:32Z</dcterms:created>
  <dcterms:modified xsi:type="dcterms:W3CDTF">2024-03-05T13:15:33Z</dcterms:modified>
</cp:coreProperties>
</file>